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1"/>
  </p:notesMasterIdLst>
  <p:sldIdLst>
    <p:sldId id="267" r:id="rId5"/>
    <p:sldId id="269" r:id="rId6"/>
    <p:sldId id="274" r:id="rId7"/>
    <p:sldId id="277" r:id="rId8"/>
    <p:sldId id="275" r:id="rId9"/>
    <p:sldId id="278" r:id="rId10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D0FC1"/>
    <a:srgbClr val="DAA600"/>
    <a:srgbClr val="FD4D73"/>
    <a:srgbClr val="FD335E"/>
    <a:srgbClr val="EC7C30"/>
    <a:srgbClr val="0CE3DE"/>
    <a:srgbClr val="A86ED4"/>
    <a:srgbClr val="0DEFEF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441" autoAdjust="0"/>
    <p:restoredTop sz="86463" autoAdjust="0"/>
  </p:normalViewPr>
  <p:slideViewPr>
    <p:cSldViewPr snapToGrid="0">
      <p:cViewPr>
        <p:scale>
          <a:sx n="180" d="100"/>
          <a:sy n="180" d="100"/>
        </p:scale>
        <p:origin x="1664" y="-6240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k Harris" userId="bfd9a973-ac62-4e0f-994c-8e95fda04071" providerId="ADAL" clId="{084CD342-E0FA-B945-A424-985452B270BC}"/>
    <pc:docChg chg="modSld">
      <pc:chgData name="Mark Harris" userId="bfd9a973-ac62-4e0f-994c-8e95fda04071" providerId="ADAL" clId="{084CD342-E0FA-B945-A424-985452B270BC}" dt="2025-01-14T14:19:00.162" v="137" actId="114"/>
      <pc:docMkLst>
        <pc:docMk/>
      </pc:docMkLst>
      <pc:sldChg chg="modSp mod">
        <pc:chgData name="Mark Harris" userId="bfd9a973-ac62-4e0f-994c-8e95fda04071" providerId="ADAL" clId="{084CD342-E0FA-B945-A424-985452B270BC}" dt="2025-01-14T14:19:00.162" v="137" actId="114"/>
        <pc:sldMkLst>
          <pc:docMk/>
          <pc:sldMk cId="436055261" sldId="267"/>
        </pc:sldMkLst>
        <pc:spChg chg="mod">
          <ac:chgData name="Mark Harris" userId="bfd9a973-ac62-4e0f-994c-8e95fda04071" providerId="ADAL" clId="{084CD342-E0FA-B945-A424-985452B270BC}" dt="2025-01-14T14:19:00.162" v="137" actId="114"/>
          <ac:spMkLst>
            <pc:docMk/>
            <pc:sldMk cId="436055261" sldId="267"/>
            <ac:spMk id="34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0703C6-BEE2-4EC8-A9A7-FD15DD37604A}" type="datetimeFigureOut">
              <a:rPr lang="en-GB" smtClean="0"/>
              <a:t>14/01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E03D36-18A3-4069-9C9C-F5CA2CD19A4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20517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E03D36-18A3-4069-9C9C-F5CA2CD19A42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11700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TNFα treatment of A549 cell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E03D36-18A3-4069-9C9C-F5CA2CD19A42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397552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Created in  https://BioRender.com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E03D36-18A3-4069-9C9C-F5CA2CD19A42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26217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61F96-B360-4AB4-9087-30F9326A0174}" type="datetimeFigureOut">
              <a:rPr lang="en-GB" smtClean="0"/>
              <a:t>14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E3B34-DE97-4406-8DB7-3105F019DF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4228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61F96-B360-4AB4-9087-30F9326A0174}" type="datetimeFigureOut">
              <a:rPr lang="en-GB" smtClean="0"/>
              <a:t>14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E3B34-DE97-4406-8DB7-3105F019DF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06275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61F96-B360-4AB4-9087-30F9326A0174}" type="datetimeFigureOut">
              <a:rPr lang="en-GB" smtClean="0"/>
              <a:t>14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E3B34-DE97-4406-8DB7-3105F019DF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823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61F96-B360-4AB4-9087-30F9326A0174}" type="datetimeFigureOut">
              <a:rPr lang="en-GB" smtClean="0"/>
              <a:t>14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E3B34-DE97-4406-8DB7-3105F019DF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4260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61F96-B360-4AB4-9087-30F9326A0174}" type="datetimeFigureOut">
              <a:rPr lang="en-GB" smtClean="0"/>
              <a:t>14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E3B34-DE97-4406-8DB7-3105F019DF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098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61F96-B360-4AB4-9087-30F9326A0174}" type="datetimeFigureOut">
              <a:rPr lang="en-GB" smtClean="0"/>
              <a:t>14/0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E3B34-DE97-4406-8DB7-3105F019DF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4768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61F96-B360-4AB4-9087-30F9326A0174}" type="datetimeFigureOut">
              <a:rPr lang="en-GB" smtClean="0"/>
              <a:t>14/01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E3B34-DE97-4406-8DB7-3105F019DF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4213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61F96-B360-4AB4-9087-30F9326A0174}" type="datetimeFigureOut">
              <a:rPr lang="en-GB" smtClean="0"/>
              <a:t>14/01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E3B34-DE97-4406-8DB7-3105F019DF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3035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61F96-B360-4AB4-9087-30F9326A0174}" type="datetimeFigureOut">
              <a:rPr lang="en-GB" smtClean="0"/>
              <a:t>14/01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E3B34-DE97-4406-8DB7-3105F019DF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9478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61F96-B360-4AB4-9087-30F9326A0174}" type="datetimeFigureOut">
              <a:rPr lang="en-GB" smtClean="0"/>
              <a:t>14/0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E3B34-DE97-4406-8DB7-3105F019DF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000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61F96-B360-4AB4-9087-30F9326A0174}" type="datetimeFigureOut">
              <a:rPr lang="en-GB" smtClean="0"/>
              <a:t>14/0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E3B34-DE97-4406-8DB7-3105F019DF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1233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D61F96-B360-4AB4-9087-30F9326A0174}" type="datetimeFigureOut">
              <a:rPr lang="en-GB" smtClean="0"/>
              <a:t>14/0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3E3B34-DE97-4406-8DB7-3105F019DFA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7931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hyperlink" Target="https://doi.org/10.1073/pnas.1621485114" TargetMode="Externa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91" t="7463" r="22066" b="5971"/>
          <a:stretch/>
        </p:blipFill>
        <p:spPr>
          <a:xfrm>
            <a:off x="571563" y="1404034"/>
            <a:ext cx="3088600" cy="3379978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00" t="15538" r="24800" b="10433"/>
          <a:stretch/>
        </p:blipFill>
        <p:spPr>
          <a:xfrm>
            <a:off x="3551588" y="1404034"/>
            <a:ext cx="2797223" cy="3379978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1594966" y="4763077"/>
            <a:ext cx="13003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DP-ribose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950199" y="4763077"/>
            <a:ext cx="6270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NA</a:t>
            </a:r>
          </a:p>
        </p:txBody>
      </p:sp>
      <p:grpSp>
        <p:nvGrpSpPr>
          <p:cNvPr id="41" name="Group 40">
            <a:extLst>
              <a:ext uri="{FF2B5EF4-FFF2-40B4-BE49-F238E27FC236}">
                <a16:creationId xmlns:a16="http://schemas.microsoft.com/office/drawing/2014/main" id="{00648AA2-B563-AF53-7183-0791DBB852DA}"/>
              </a:ext>
            </a:extLst>
          </p:cNvPr>
          <p:cNvGrpSpPr/>
          <p:nvPr/>
        </p:nvGrpSpPr>
        <p:grpSpPr>
          <a:xfrm>
            <a:off x="568100" y="3395805"/>
            <a:ext cx="734037" cy="338554"/>
            <a:chOff x="417020" y="5346120"/>
            <a:chExt cx="734037" cy="338554"/>
          </a:xfrm>
        </p:grpSpPr>
        <p:sp>
          <p:nvSpPr>
            <p:cNvPr id="7" name="TextBox 6"/>
            <p:cNvSpPr txBox="1"/>
            <p:nvPr/>
          </p:nvSpPr>
          <p:spPr>
            <a:xfrm>
              <a:off x="417020" y="5346120"/>
              <a:ext cx="720080" cy="338554"/>
            </a:xfrm>
            <a:prstGeom prst="rect">
              <a:avLst/>
            </a:prstGeom>
            <a:solidFill>
              <a:srgbClr val="FFFFFF">
                <a:alpha val="60000"/>
              </a:srgbClr>
            </a:solidFill>
            <a:effectLst>
              <a:softEdge rad="31750"/>
            </a:effectLst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600" b="1" i="0" u="none" strike="noStrike" kern="0" cap="none" spc="0" normalizeH="0" baseline="0" noProof="0" dirty="0">
                  <a:ln>
                    <a:noFill/>
                  </a:ln>
                  <a:solidFill>
                    <a:srgbClr val="BD0FC1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10</a:t>
              </a:r>
            </a:p>
          </p:txBody>
        </p:sp>
        <p:cxnSp>
          <p:nvCxnSpPr>
            <p:cNvPr id="22" name="Straight Connector 21"/>
            <p:cNvCxnSpPr>
              <a:cxnSpLocks/>
            </p:cNvCxnSpPr>
            <p:nvPr/>
          </p:nvCxnSpPr>
          <p:spPr>
            <a:xfrm flipV="1">
              <a:off x="993224" y="5463732"/>
              <a:ext cx="157833" cy="42035"/>
            </a:xfrm>
            <a:prstGeom prst="line">
              <a:avLst/>
            </a:prstGeom>
            <a:noFill/>
            <a:ln w="2857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</p:grpSp>
      <p:sp>
        <p:nvSpPr>
          <p:cNvPr id="34" name="TextBox 33"/>
          <p:cNvSpPr txBox="1"/>
          <p:nvPr/>
        </p:nvSpPr>
        <p:spPr>
          <a:xfrm>
            <a:off x="488546" y="7614674"/>
            <a:ext cx="5924089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 (a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chematic of the 3-domain structure of nsP3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Structure of the CHIKV macro domain in complex with ADP-ribose (left) or RNA (right). Residues highlighted in magenta have been previously shown to be key to binding or RNA or ADPR, or important for ADP-hydrolase activity (McPherson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et al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2017).  PDB accession numbers 3GPO and 3GPQ respectively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equence alignment of nsP3 macro domains from CHIKV, SINV (Strauss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1984), and VEEV (</a:t>
            </a:r>
            <a:r>
              <a:rPr lang="en-GB" sz="1200" b="0" i="0" dirty="0" err="1">
                <a:solidFill>
                  <a:srgbClr val="1F1F1F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Makrynitsa</a:t>
            </a:r>
            <a:r>
              <a:rPr lang="en-GB" sz="1200" b="0" i="0" dirty="0">
                <a:solidFill>
                  <a:srgbClr val="1F1F1F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b="0" i="1" dirty="0">
                <a:solidFill>
                  <a:srgbClr val="1F1F1F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t al. </a:t>
            </a:r>
            <a:r>
              <a:rPr lang="en-GB" sz="1200" b="0" dirty="0">
                <a:solidFill>
                  <a:srgbClr val="1F1F1F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2019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), generated using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ClustalOmega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(Sievers 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et al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2011). (Completely conserved residues are denoted with *. Residues that are not conserved but retain similar physicochemical properties are denoted with :, those with altered physicochemical properties with .). </a:t>
            </a:r>
          </a:p>
        </p:txBody>
      </p:sp>
      <p:sp>
        <p:nvSpPr>
          <p:cNvPr id="35" name="AutoShape 10"/>
          <p:cNvSpPr>
            <a:spLocks noChangeArrowheads="1"/>
          </p:cNvSpPr>
          <p:nvPr/>
        </p:nvSpPr>
        <p:spPr bwMode="auto">
          <a:xfrm>
            <a:off x="576353" y="686924"/>
            <a:ext cx="1723302" cy="381407"/>
          </a:xfrm>
          <a:prstGeom prst="roundRect">
            <a:avLst>
              <a:gd name="adj" fmla="val 22279"/>
            </a:avLst>
          </a:prstGeom>
          <a:solidFill>
            <a:srgbClr val="0CE3DE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AutoShape 11"/>
          <p:cNvSpPr>
            <a:spLocks noChangeArrowheads="1"/>
          </p:cNvSpPr>
          <p:nvPr/>
        </p:nvSpPr>
        <p:spPr bwMode="auto">
          <a:xfrm>
            <a:off x="2300135" y="686924"/>
            <a:ext cx="2300913" cy="381407"/>
          </a:xfrm>
          <a:prstGeom prst="roundRect">
            <a:avLst>
              <a:gd name="adj" fmla="val 23293"/>
            </a:avLst>
          </a:prstGeom>
          <a:solidFill>
            <a:srgbClr val="FD4D73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AutoShape 12"/>
          <p:cNvSpPr>
            <a:spLocks noChangeArrowheads="1"/>
          </p:cNvSpPr>
          <p:nvPr/>
        </p:nvSpPr>
        <p:spPr bwMode="auto">
          <a:xfrm>
            <a:off x="4601049" y="686924"/>
            <a:ext cx="1891140" cy="381407"/>
          </a:xfrm>
          <a:prstGeom prst="roundRect">
            <a:avLst>
              <a:gd name="adj" fmla="val 21265"/>
            </a:avLst>
          </a:prstGeom>
          <a:solidFill>
            <a:srgbClr val="DAA600"/>
          </a:solidFill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200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766472" y="746822"/>
            <a:ext cx="5725719" cy="261610"/>
            <a:chOff x="766474" y="822038"/>
            <a:chExt cx="5725719" cy="261610"/>
          </a:xfrm>
        </p:grpSpPr>
        <p:sp>
          <p:nvSpPr>
            <p:cNvPr id="38" name="Text Box 3291"/>
            <p:cNvSpPr txBox="1">
              <a:spLocks noChangeArrowheads="1"/>
            </p:cNvSpPr>
            <p:nvPr/>
          </p:nvSpPr>
          <p:spPr bwMode="auto">
            <a:xfrm>
              <a:off x="766474" y="822038"/>
              <a:ext cx="1349391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Macro domain </a:t>
              </a:r>
            </a:p>
          </p:txBody>
        </p:sp>
        <p:sp>
          <p:nvSpPr>
            <p:cNvPr id="39" name="Text Box 3292"/>
            <p:cNvSpPr txBox="1">
              <a:spLocks noChangeArrowheads="1"/>
            </p:cNvSpPr>
            <p:nvPr/>
          </p:nvSpPr>
          <p:spPr bwMode="auto">
            <a:xfrm>
              <a:off x="2273779" y="822038"/>
              <a:ext cx="2066121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lphavirus Unique Domain</a:t>
              </a:r>
            </a:p>
          </p:txBody>
        </p:sp>
        <p:sp>
          <p:nvSpPr>
            <p:cNvPr id="40" name="Text Box 3293"/>
            <p:cNvSpPr txBox="1">
              <a:spLocks noChangeArrowheads="1"/>
            </p:cNvSpPr>
            <p:nvPr/>
          </p:nvSpPr>
          <p:spPr bwMode="auto">
            <a:xfrm>
              <a:off x="4601051" y="822038"/>
              <a:ext cx="1891142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Hyper-variable domain</a:t>
              </a:r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438016" y="271193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438016" y="1625600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4" name="Rectangle 3"/>
          <p:cNvSpPr/>
          <p:nvPr/>
        </p:nvSpPr>
        <p:spPr>
          <a:xfrm>
            <a:off x="4267034" y="686924"/>
            <a:ext cx="171771" cy="381407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vert="vert" rtlCol="0" anchor="ctr"/>
          <a:lstStyle/>
          <a:p>
            <a:pPr algn="ctr"/>
            <a:r>
              <a:rPr lang="en-GB" sz="1200" dirty="0"/>
              <a:t>Zn</a:t>
            </a: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2BD3620F-5C13-C357-1BBD-204B2112899A}"/>
              </a:ext>
            </a:extLst>
          </p:cNvPr>
          <p:cNvGrpSpPr/>
          <p:nvPr/>
        </p:nvGrpSpPr>
        <p:grpSpPr>
          <a:xfrm>
            <a:off x="3498867" y="3395805"/>
            <a:ext cx="734037" cy="338554"/>
            <a:chOff x="417020" y="5346120"/>
            <a:chExt cx="734037" cy="338554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8D539DEB-5E2D-D30E-6B44-12B438BA6D51}"/>
                </a:ext>
              </a:extLst>
            </p:cNvPr>
            <p:cNvSpPr txBox="1"/>
            <p:nvPr/>
          </p:nvSpPr>
          <p:spPr>
            <a:xfrm>
              <a:off x="417020" y="5346120"/>
              <a:ext cx="720080" cy="338554"/>
            </a:xfrm>
            <a:prstGeom prst="rect">
              <a:avLst/>
            </a:prstGeom>
            <a:solidFill>
              <a:srgbClr val="FFFFFF">
                <a:alpha val="60000"/>
              </a:srgbClr>
            </a:solidFill>
            <a:effectLst>
              <a:softEdge rad="31750"/>
            </a:effectLst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600" b="1" i="0" u="none" strike="noStrike" kern="0" cap="none" spc="0" normalizeH="0" baseline="0" noProof="0" dirty="0">
                  <a:ln>
                    <a:noFill/>
                  </a:ln>
                  <a:solidFill>
                    <a:srgbClr val="BD0FC1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rPr>
                <a:t>D10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4A29BDE2-9F63-DD61-553B-D4BDC4718CC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93224" y="5463732"/>
              <a:ext cx="157833" cy="42035"/>
            </a:xfrm>
            <a:prstGeom prst="line">
              <a:avLst/>
            </a:prstGeom>
            <a:noFill/>
            <a:ln w="2857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</p:grpSp>
      <p:pic>
        <p:nvPicPr>
          <p:cNvPr id="5" name="Picture 4">
            <a:extLst>
              <a:ext uri="{FF2B5EF4-FFF2-40B4-BE49-F238E27FC236}">
                <a16:creationId xmlns:a16="http://schemas.microsoft.com/office/drawing/2014/main" id="{D8551094-84EE-2641-A638-30199BA402A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065" t="5879" r="4464" b="3544"/>
          <a:stretch/>
        </p:blipFill>
        <p:spPr>
          <a:xfrm>
            <a:off x="821783" y="5330988"/>
            <a:ext cx="5527028" cy="222630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8F96D24-5833-F596-7EE6-24F56FAF0936}"/>
              </a:ext>
            </a:extLst>
          </p:cNvPr>
          <p:cNvSpPr txBox="1"/>
          <p:nvPr/>
        </p:nvSpPr>
        <p:spPr>
          <a:xfrm>
            <a:off x="438016" y="4965826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4360552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6976327"/>
              </p:ext>
            </p:extLst>
          </p:nvPr>
        </p:nvGraphicFramePr>
        <p:xfrm>
          <a:off x="1403994" y="1327150"/>
          <a:ext cx="4344987" cy="3595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4345037" imgH="3595058" progId="Prism9.Document">
                  <p:embed/>
                </p:oleObj>
              </mc:Choice>
              <mc:Fallback>
                <p:oleObj name="Prism 9" r:id="rId2" imgW="4345037" imgH="3595058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03994" y="1327150"/>
                        <a:ext cx="4344987" cy="3595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42809" y="4833268"/>
            <a:ext cx="60928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 CHIKV virus production in range of cell lines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ndicated cell lines were infected with CHIKV at MOI=1, incubated 2h, prior to thorough washing and media replacement. Supernatant was collected at 24 and 48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h.p.i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and titred via plaque assay on BHK cells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93800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3710715"/>
              </p:ext>
            </p:extLst>
          </p:nvPr>
        </p:nvGraphicFramePr>
        <p:xfrm>
          <a:off x="1712912" y="4033837"/>
          <a:ext cx="3432175" cy="2959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119135" imgH="2691071" progId="Prism9.Document">
                  <p:embed/>
                </p:oleObj>
              </mc:Choice>
              <mc:Fallback>
                <p:oleObj name="Prism 9" r:id="rId3" imgW="3119135" imgH="2691071" progId="Prism9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712912" y="4033837"/>
                        <a:ext cx="3432175" cy="2959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24079" y="7196138"/>
            <a:ext cx="623533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 Optimisation of TNF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treatment in A549 cells. (a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549 cells were transfected with NF-кB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porter plasmids 16 h prior to TNF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treatment at 50 ng/mL, or mock treated. Cells were lysed at either 6 or 24 hpt and assayed for luciferase. 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549 cells were transfected with NF-кB</a:t>
            </a:r>
            <a:r>
              <a:rPr lang="en-GB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reporter plasmids 16 h prior to TNF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treatment at indicated concentrations. Cells were lysed at 8 hpt and assayed for luciferase activity. Data shown as fold change of NF-кB activation over mock treated cells. 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6685822"/>
              </p:ext>
            </p:extLst>
          </p:nvPr>
        </p:nvGraphicFramePr>
        <p:xfrm>
          <a:off x="1566700" y="1215926"/>
          <a:ext cx="4176713" cy="2692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4177214" imgH="2692512" progId="Prism10.Document">
                  <p:embed/>
                </p:oleObj>
              </mc:Choice>
              <mc:Fallback>
                <p:oleObj name="Prism 10" r:id="rId5" imgW="4177214" imgH="2692512" progId="Prism10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566700" y="1215926"/>
                        <a:ext cx="4176713" cy="2692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533E8316-550D-9973-F46F-EBCBB8A1FFB4}"/>
              </a:ext>
            </a:extLst>
          </p:cNvPr>
          <p:cNvSpPr txBox="1"/>
          <p:nvPr/>
        </p:nvSpPr>
        <p:spPr>
          <a:xfrm>
            <a:off x="1365363" y="782638"/>
            <a:ext cx="4026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9A87A7F-3331-453B-95AA-9672874F958C}"/>
              </a:ext>
            </a:extLst>
          </p:cNvPr>
          <p:cNvSpPr txBox="1"/>
          <p:nvPr/>
        </p:nvSpPr>
        <p:spPr>
          <a:xfrm>
            <a:off x="1365363" y="3600549"/>
            <a:ext cx="4122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299808266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08548B-4FDE-48BF-F4F9-AF2EBC6A7D8D}"/>
              </a:ext>
            </a:extLst>
          </p:cNvPr>
          <p:cNvSpPr txBox="1"/>
          <p:nvPr/>
        </p:nvSpPr>
        <p:spPr>
          <a:xfrm>
            <a:off x="754195" y="3956846"/>
            <a:ext cx="580504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</a:t>
            </a:r>
            <a:r>
              <a:rPr lang="en-GB" sz="18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chematic of IKK complex activation. Image created in  https://BioRender.com</a:t>
            </a:r>
          </a:p>
          <a:p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 descr="A diagram of a cell line&#10;&#10;Description automatically generated">
            <a:extLst>
              <a:ext uri="{FF2B5EF4-FFF2-40B4-BE49-F238E27FC236}">
                <a16:creationId xmlns:a16="http://schemas.microsoft.com/office/drawing/2014/main" id="{815CC567-26E5-7069-67DE-AB70E513283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19"/>
          <a:stretch/>
        </p:blipFill>
        <p:spPr>
          <a:xfrm>
            <a:off x="956733" y="197102"/>
            <a:ext cx="4944534" cy="35850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53962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361543" y="1620549"/>
            <a:ext cx="5947716" cy="4442187"/>
            <a:chOff x="460397" y="743219"/>
            <a:chExt cx="5947716" cy="4442187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7513" y="1104782"/>
              <a:ext cx="5400600" cy="1346702"/>
            </a:xfrm>
            <a:prstGeom prst="rect">
              <a:avLst/>
            </a:prstGeom>
            <a:ln>
              <a:noFill/>
            </a:ln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7513" y="2461059"/>
              <a:ext cx="5400600" cy="1346702"/>
            </a:xfrm>
            <a:prstGeom prst="rect">
              <a:avLst/>
            </a:prstGeom>
            <a:ln>
              <a:noFill/>
            </a:ln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7513" y="3838704"/>
              <a:ext cx="5400599" cy="1346702"/>
            </a:xfrm>
            <a:prstGeom prst="rect">
              <a:avLst/>
            </a:prstGeom>
            <a:ln>
              <a:noFill/>
            </a:ln>
          </p:spPr>
        </p:pic>
        <p:sp>
          <p:nvSpPr>
            <p:cNvPr id="9" name="TextBox 8"/>
            <p:cNvSpPr txBox="1"/>
            <p:nvPr/>
          </p:nvSpPr>
          <p:spPr>
            <a:xfrm>
              <a:off x="1320184" y="752297"/>
              <a:ext cx="6142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rgbClr val="0000F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485009" y="743219"/>
              <a:ext cx="88197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rgbClr val="0098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RTD10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039469" y="744130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sP3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285701" y="751717"/>
              <a:ext cx="72327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03065" y="1578078"/>
              <a:ext cx="4427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h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03065" y="2934355"/>
              <a:ext cx="4427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 h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60397" y="4312000"/>
              <a:ext cx="5421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526476" y="6284729"/>
            <a:ext cx="58050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. 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Huh7 cells infected with CHIKV (MOI = 5) were fixed at indicated time points post infection, and stained for ARTD10 (green) and nsP3 (red).</a:t>
            </a:r>
          </a:p>
        </p:txBody>
      </p:sp>
    </p:spTree>
    <p:extLst>
      <p:ext uri="{BB962C8B-B14F-4D97-AF65-F5344CB8AC3E}">
        <p14:creationId xmlns:p14="http://schemas.microsoft.com/office/powerpoint/2010/main" val="9127993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E63749E-0EB5-BA1A-91F3-50FC9A5AD3EC}"/>
              </a:ext>
            </a:extLst>
          </p:cNvPr>
          <p:cNvSpPr txBox="1"/>
          <p:nvPr/>
        </p:nvSpPr>
        <p:spPr>
          <a:xfrm>
            <a:off x="467834" y="668691"/>
            <a:ext cx="5911702" cy="41890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GB" sz="1200" b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References</a:t>
            </a:r>
            <a:endParaRPr lang="en-GB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akrynitsa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G,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tonti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D, 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arousis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KD,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irkou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M,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atsoukas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M-T,  Asami S, 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Bentrop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D, 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Papageorgiou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N, Canard B,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outard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B, 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pyroulias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GA. Conformational plasticity of the VEEV macro domain is important for binding of ADP-ribose. </a:t>
            </a:r>
            <a:r>
              <a:rPr lang="en-GB" sz="120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 (Body CS)"/>
              </a:rPr>
              <a:t>J Struct </a:t>
            </a:r>
            <a:r>
              <a:rPr lang="en-GB" sz="1200" i="1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 (Body CS)"/>
              </a:rPr>
              <a:t>Biol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2019 Apr 1;206(1):119-127. 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oi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: 10.1016/j.jsb.2019.02.008. 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Epub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2019 Feb 27.</a:t>
            </a:r>
            <a:endParaRPr lang="en-GB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spcBef>
                <a:spcPts val="600"/>
              </a:spcBef>
            </a:pP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cPherson, R. L., Abraham, R., Sreekumar, E., Ong, S.-E., Cheng, S.-J., Baxter, V. K., Kistemaker, H. A. V, Filippov, D. V, Griffin, D. E., &amp; Leung, A. K. L. (2017). ADP-</a:t>
            </a:r>
            <a:r>
              <a:rPr lang="en-GB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ibosylhydrolase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ctivity of Chikungunya virus macrodomain is critical for virus replication and virulence. 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NAS (USA)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14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7), 1666–1671. </a:t>
            </a:r>
            <a:r>
              <a:rPr lang="en-GB" sz="1200" u="sng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https://doi.org/10.1073/pnas.1621485114</a:t>
            </a:r>
            <a:endParaRPr lang="en-GB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95000"/>
              </a:lnSpc>
              <a:spcBef>
                <a:spcPts val="600"/>
              </a:spcBef>
            </a:pP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GB" sz="12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ievers F,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Wilm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, Dineen D, Gibson TJ, Karplus K, Li W, Lopez R, McWilliam H,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emmert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M,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öding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J, Thompson JD, Higgins DG.  Fast, scalable generation of high-quality protein multiple sequence alignments using 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Clustal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 Omega.  </a:t>
            </a:r>
            <a:r>
              <a:rPr lang="en-GB" sz="120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 (Body CS)"/>
              </a:rPr>
              <a:t>Mol </a:t>
            </a:r>
            <a:r>
              <a:rPr lang="en-GB" sz="1200" i="1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 (Body CS)"/>
              </a:rPr>
              <a:t>Syst</a:t>
            </a:r>
            <a:r>
              <a:rPr lang="en-GB" sz="120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 (Body CS)"/>
              </a:rPr>
              <a:t> Biol.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2011 Oct 11;7:539.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oi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: 10.1038/msb.2011.75</a:t>
            </a:r>
            <a:endParaRPr lang="en-GB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trauss EG, Rice CM, Strauss JH. Complete nucleotide sequence of the genomic RNA of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indbis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virus. </a:t>
            </a:r>
            <a:r>
              <a:rPr lang="en-GB" sz="1200" i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 (Body CS)"/>
              </a:rPr>
              <a:t>Virology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1984 Feb;133(1):92-110. </a:t>
            </a:r>
            <a:r>
              <a:rPr lang="en-GB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doi</a:t>
            </a:r>
            <a:r>
              <a:rPr lang="en-GB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: 10.1016/0042-6822(84)90428-8. PMID: 6322438</a:t>
            </a:r>
            <a:endParaRPr lang="en-GB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5166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6cabbfcd-96f4-4782-be12-fe96a619fb81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889B1278F311144897AA22D48146D13" ma:contentTypeVersion="15" ma:contentTypeDescription="Create a new document." ma:contentTypeScope="" ma:versionID="830f3b96bf53c8c8a7cca8377aebe052">
  <xsd:schema xmlns:xsd="http://www.w3.org/2001/XMLSchema" xmlns:xs="http://www.w3.org/2001/XMLSchema" xmlns:p="http://schemas.microsoft.com/office/2006/metadata/properties" xmlns:ns3="6cabbfcd-96f4-4782-be12-fe96a619fb81" xmlns:ns4="03a1ce47-ff91-4d6c-99e5-a0c879db6d2c" targetNamespace="http://schemas.microsoft.com/office/2006/metadata/properties" ma:root="true" ma:fieldsID="a0b6cc7c70c9a820f0cb33269f903c67" ns3:_="" ns4:_="">
    <xsd:import namespace="6cabbfcd-96f4-4782-be12-fe96a619fb81"/>
    <xsd:import namespace="03a1ce47-ff91-4d6c-99e5-a0c879db6d2c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cabbfcd-96f4-4782-be12-fe96a619fb8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9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3a1ce47-ff91-4d6c-99e5-a0c879db6d2c" elementFormDefault="qualified">
    <xsd:import namespace="http://schemas.microsoft.com/office/2006/documentManagement/types"/>
    <xsd:import namespace="http://schemas.microsoft.com/office/infopath/2007/PartnerControls"/>
    <xsd:element name="SharedWithUsers" ma:index="15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6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7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7944367-79E5-455A-87E8-C7D4EB0BE9A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875C930-2053-47AE-89A7-0A94FED39899}">
  <ds:schemaRefs>
    <ds:schemaRef ds:uri="03a1ce47-ff91-4d6c-99e5-a0c879db6d2c"/>
    <ds:schemaRef ds:uri="http://schemas.microsoft.com/office/2006/documentManagement/types"/>
    <ds:schemaRef ds:uri="http://www.w3.org/XML/1998/namespace"/>
    <ds:schemaRef ds:uri="http://purl.org/dc/dcmitype/"/>
    <ds:schemaRef ds:uri="http://schemas.microsoft.com/office/2006/metadata/properties"/>
    <ds:schemaRef ds:uri="http://purl.org/dc/elements/1.1/"/>
    <ds:schemaRef ds:uri="6cabbfcd-96f4-4782-be12-fe96a619fb81"/>
    <ds:schemaRef ds:uri="http://schemas.microsoft.com/office/infopath/2007/PartnerControls"/>
    <ds:schemaRef ds:uri="http://schemas.openxmlformats.org/package/2006/metadata/core-properties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23B5EB44-9764-4564-BE28-5C9DE64F619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cabbfcd-96f4-4782-be12-fe96a619fb81"/>
    <ds:schemaRef ds:uri="03a1ce47-ff91-4d6c-99e5-a0c879db6d2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51</TotalTime>
  <Words>676</Words>
  <Application>Microsoft Macintosh PowerPoint</Application>
  <PresentationFormat>A4 Paper (210x297 mm)</PresentationFormat>
  <Paragraphs>36</Paragraphs>
  <Slides>6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ptos</vt:lpstr>
      <vt:lpstr>Arial</vt:lpstr>
      <vt:lpstr>Calibri</vt:lpstr>
      <vt:lpstr>Calibri Light</vt:lpstr>
      <vt:lpstr>Palatino Linotype</vt:lpstr>
      <vt:lpstr>Office Theme</vt:lpstr>
      <vt:lpstr>Prism 9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Leed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ace Roberts [RPG]</dc:creator>
  <cp:lastModifiedBy>Mark Harris</cp:lastModifiedBy>
  <cp:revision>158</cp:revision>
  <cp:lastPrinted>2019-08-02T09:02:39Z</cp:lastPrinted>
  <dcterms:created xsi:type="dcterms:W3CDTF">2019-02-26T17:56:08Z</dcterms:created>
  <dcterms:modified xsi:type="dcterms:W3CDTF">2025-01-14T14:19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889B1278F311144897AA22D48146D13</vt:lpwstr>
  </property>
</Properties>
</file>